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35" autoAdjust="0"/>
    <p:restoredTop sz="94660"/>
  </p:normalViewPr>
  <p:slideViewPr>
    <p:cSldViewPr snapToGrid="0">
      <p:cViewPr varScale="1">
        <p:scale>
          <a:sx n="34" d="100"/>
          <a:sy n="34" d="100"/>
        </p:scale>
        <p:origin x="2412" y="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nexus.csiro.au\fileservers\fsact01-cdc\PI\Share1\ProgS\SC%20-%20(Mick%20Ayliffe)\Mick\bromoform\PAPER\VHPO%20activity%20optimisation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nexus.csiro.au\fileservers\fsact01-cdc\PI\Share1\ProgS\SC%20-%20(Mick%20Ayliffe)\Mick\bromoform\PAPER\VHPO%20activity%20optimisations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565525550607315"/>
          <c:y val="1.6980627210218327E-2"/>
          <c:w val="0.8520978073453781"/>
          <c:h val="0.7471659817869402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C$12:$C$27</c:f>
                <c:numCache>
                  <c:formatCode>General</c:formatCode>
                  <c:ptCount val="16"/>
                  <c:pt idx="0">
                    <c:v>1.6026486602256851E-7</c:v>
                  </c:pt>
                  <c:pt idx="1">
                    <c:v>6.9086537682017972E-9</c:v>
                  </c:pt>
                  <c:pt idx="2">
                    <c:v>7.1445450936750035E-8</c:v>
                  </c:pt>
                  <c:pt idx="3">
                    <c:v>2.6017482101319235E-5</c:v>
                  </c:pt>
                  <c:pt idx="4">
                    <c:v>1.3414510186941436E-5</c:v>
                  </c:pt>
                  <c:pt idx="5">
                    <c:v>1.3355603825943459E-5</c:v>
                  </c:pt>
                  <c:pt idx="6">
                    <c:v>1.0224461952700603E-6</c:v>
                  </c:pt>
                  <c:pt idx="7">
                    <c:v>2.1467908219841905E-7</c:v>
                  </c:pt>
                  <c:pt idx="8">
                    <c:v>1.079885332293614E-6</c:v>
                  </c:pt>
                  <c:pt idx="9">
                    <c:v>2.6656339295684748E-7</c:v>
                  </c:pt>
                  <c:pt idx="10">
                    <c:v>3.9104890572237463E-9</c:v>
                  </c:pt>
                  <c:pt idx="11">
                    <c:v>6.4768691388835563E-8</c:v>
                  </c:pt>
                  <c:pt idx="12">
                    <c:v>1.4395733953101059E-6</c:v>
                  </c:pt>
                  <c:pt idx="13">
                    <c:v>9.7154578627166213E-8</c:v>
                  </c:pt>
                  <c:pt idx="14">
                    <c:v>2.4546961473132811E-6</c:v>
                  </c:pt>
                  <c:pt idx="15">
                    <c:v>4.7140452079103163E-5</c:v>
                  </c:pt>
                </c:numCache>
              </c:numRef>
            </c:plus>
            <c:minus>
              <c:numRef>
                <c:f>Sheet1!$C$12:$C$27</c:f>
                <c:numCache>
                  <c:formatCode>General</c:formatCode>
                  <c:ptCount val="16"/>
                  <c:pt idx="0">
                    <c:v>1.6026486602256851E-7</c:v>
                  </c:pt>
                  <c:pt idx="1">
                    <c:v>6.9086537682017972E-9</c:v>
                  </c:pt>
                  <c:pt idx="2">
                    <c:v>7.1445450936750035E-8</c:v>
                  </c:pt>
                  <c:pt idx="3">
                    <c:v>2.6017482101319235E-5</c:v>
                  </c:pt>
                  <c:pt idx="4">
                    <c:v>1.3414510186941436E-5</c:v>
                  </c:pt>
                  <c:pt idx="5">
                    <c:v>1.3355603825943459E-5</c:v>
                  </c:pt>
                  <c:pt idx="6">
                    <c:v>1.0224461952700603E-6</c:v>
                  </c:pt>
                  <c:pt idx="7">
                    <c:v>2.1467908219841905E-7</c:v>
                  </c:pt>
                  <c:pt idx="8">
                    <c:v>1.079885332293614E-6</c:v>
                  </c:pt>
                  <c:pt idx="9">
                    <c:v>2.6656339295684748E-7</c:v>
                  </c:pt>
                  <c:pt idx="10">
                    <c:v>3.9104890572237463E-9</c:v>
                  </c:pt>
                  <c:pt idx="11">
                    <c:v>6.4768691388835563E-8</c:v>
                  </c:pt>
                  <c:pt idx="12">
                    <c:v>1.4395733953101059E-6</c:v>
                  </c:pt>
                  <c:pt idx="13">
                    <c:v>9.7154578627166213E-8</c:v>
                  </c:pt>
                  <c:pt idx="14">
                    <c:v>2.4546961473132811E-6</c:v>
                  </c:pt>
                  <c:pt idx="15">
                    <c:v>4.7140452079103163E-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12:$A$27</c:f>
              <c:strCache>
                <c:ptCount val="16"/>
                <c:pt idx="0">
                  <c:v>LMM + 0.5 g/L glucose </c:v>
                </c:pt>
                <c:pt idx="1">
                  <c:v>LMM + 2 g/L glucose</c:v>
                </c:pt>
                <c:pt idx="2">
                  <c:v>LMM + 4 g/L glucose</c:v>
                </c:pt>
                <c:pt idx="3">
                  <c:v>LMM + 6 g/L glucose </c:v>
                </c:pt>
                <c:pt idx="4">
                  <c:v>LMM + 8 g/L glucose </c:v>
                </c:pt>
                <c:pt idx="5">
                  <c:v>LMM + 10 g/L glucose </c:v>
                </c:pt>
                <c:pt idx="6">
                  <c:v>LMM + 15 g/L glucose </c:v>
                </c:pt>
                <c:pt idx="7">
                  <c:v>LMM + 20 g/L glucose </c:v>
                </c:pt>
                <c:pt idx="8">
                  <c:v>LMM + 25 g/L glucose </c:v>
                </c:pt>
                <c:pt idx="9">
                  <c:v>LMM +30 g/L glucose </c:v>
                </c:pt>
                <c:pt idx="10">
                  <c:v>LMM + 35 g/L glucose </c:v>
                </c:pt>
                <c:pt idx="11">
                  <c:v>LMM + 40 g/L glucose </c:v>
                </c:pt>
                <c:pt idx="12">
                  <c:v>LMM + 1% glycerol </c:v>
                </c:pt>
                <c:pt idx="13">
                  <c:v>LMM + 1 mM palmitic acid</c:v>
                </c:pt>
                <c:pt idx="14">
                  <c:v>0.5 x potato dextrose broth</c:v>
                </c:pt>
                <c:pt idx="15">
                  <c:v>LMM + 8 g/L glucose + 0.4 g/L agar </c:v>
                </c:pt>
              </c:strCache>
            </c:strRef>
          </c:cat>
          <c:val>
            <c:numRef>
              <c:f>Sheet1!$B$12:$B$27</c:f>
              <c:numCache>
                <c:formatCode>General</c:formatCode>
                <c:ptCount val="16"/>
                <c:pt idx="0">
                  <c:v>2.5737405882352936E-7</c:v>
                </c:pt>
                <c:pt idx="1">
                  <c:v>-2.7705666666666667E-8</c:v>
                </c:pt>
                <c:pt idx="2">
                  <c:v>1.0555933333333333E-7</c:v>
                </c:pt>
                <c:pt idx="3">
                  <c:v>3.1228729999999997E-5</c:v>
                </c:pt>
                <c:pt idx="4">
                  <c:v>5.8249333333333332E-5</c:v>
                </c:pt>
                <c:pt idx="5">
                  <c:v>2.6507333333333333E-5</c:v>
                </c:pt>
                <c:pt idx="6">
                  <c:v>3.3056666666666666E-6</c:v>
                </c:pt>
                <c:pt idx="7">
                  <c:v>6.6770166666666658E-7</c:v>
                </c:pt>
                <c:pt idx="8">
                  <c:v>-8.2399766666666657E-7</c:v>
                </c:pt>
                <c:pt idx="9">
                  <c:v>1.2067300000000001E-7</c:v>
                </c:pt>
                <c:pt idx="10">
                  <c:v>-2.4321999999999998E-8</c:v>
                </c:pt>
                <c:pt idx="11">
                  <c:v>-7.3181333333333328E-8</c:v>
                </c:pt>
                <c:pt idx="12">
                  <c:v>3.3723633333333336E-7</c:v>
                </c:pt>
                <c:pt idx="13">
                  <c:v>2.573276666666667E-7</c:v>
                </c:pt>
                <c:pt idx="14">
                  <c:v>2.6070219999999995E-6</c:v>
                </c:pt>
                <c:pt idx="15">
                  <c:v>4.3333333333333299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738-4186-9DC4-A178D8FA301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1561760"/>
        <c:axId val="31562720"/>
      </c:barChart>
      <c:catAx>
        <c:axId val="315617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1562720"/>
        <c:crosses val="autoZero"/>
        <c:auto val="1"/>
        <c:lblAlgn val="ctr"/>
        <c:lblOffset val="100"/>
        <c:noMultiLvlLbl val="0"/>
      </c:catAx>
      <c:valAx>
        <c:axId val="31562720"/>
        <c:scaling>
          <c:orientation val="minMax"/>
          <c:min val="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156176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C$12:$C$26</c:f>
                <c:numCache>
                  <c:formatCode>General</c:formatCode>
                  <c:ptCount val="15"/>
                  <c:pt idx="0">
                    <c:v>1.6026486602256851E-7</c:v>
                  </c:pt>
                  <c:pt idx="1">
                    <c:v>6.9086537682017972E-9</c:v>
                  </c:pt>
                  <c:pt idx="2">
                    <c:v>7.1445450936750035E-8</c:v>
                  </c:pt>
                  <c:pt idx="3">
                    <c:v>2.6017482101319235E-5</c:v>
                  </c:pt>
                  <c:pt idx="4">
                    <c:v>1.3414510186941436E-5</c:v>
                  </c:pt>
                  <c:pt idx="5">
                    <c:v>1.3355603825943459E-5</c:v>
                  </c:pt>
                  <c:pt idx="6">
                    <c:v>1.0224461952700603E-6</c:v>
                  </c:pt>
                  <c:pt idx="7">
                    <c:v>2.1467908219841905E-7</c:v>
                  </c:pt>
                  <c:pt idx="8">
                    <c:v>1.079885332293614E-6</c:v>
                  </c:pt>
                  <c:pt idx="9">
                    <c:v>2.6656339295684748E-7</c:v>
                  </c:pt>
                  <c:pt idx="10">
                    <c:v>3.9104890572237463E-9</c:v>
                  </c:pt>
                  <c:pt idx="11">
                    <c:v>6.4768691388835563E-8</c:v>
                  </c:pt>
                  <c:pt idx="12">
                    <c:v>1.4395733953101059E-6</c:v>
                  </c:pt>
                  <c:pt idx="13">
                    <c:v>9.7154578627166213E-8</c:v>
                  </c:pt>
                  <c:pt idx="14">
                    <c:v>2.4546961473132811E-6</c:v>
                  </c:pt>
                </c:numCache>
              </c:numRef>
            </c:plus>
            <c:minus>
              <c:numRef>
                <c:f>Sheet1!$C$12:$C$26</c:f>
                <c:numCache>
                  <c:formatCode>General</c:formatCode>
                  <c:ptCount val="15"/>
                  <c:pt idx="0">
                    <c:v>1.6026486602256851E-7</c:v>
                  </c:pt>
                  <c:pt idx="1">
                    <c:v>6.9086537682017972E-9</c:v>
                  </c:pt>
                  <c:pt idx="2">
                    <c:v>7.1445450936750035E-8</c:v>
                  </c:pt>
                  <c:pt idx="3">
                    <c:v>2.6017482101319235E-5</c:v>
                  </c:pt>
                  <c:pt idx="4">
                    <c:v>1.3414510186941436E-5</c:v>
                  </c:pt>
                  <c:pt idx="5">
                    <c:v>1.3355603825943459E-5</c:v>
                  </c:pt>
                  <c:pt idx="6">
                    <c:v>1.0224461952700603E-6</c:v>
                  </c:pt>
                  <c:pt idx="7">
                    <c:v>2.1467908219841905E-7</c:v>
                  </c:pt>
                  <c:pt idx="8">
                    <c:v>1.079885332293614E-6</c:v>
                  </c:pt>
                  <c:pt idx="9">
                    <c:v>2.6656339295684748E-7</c:v>
                  </c:pt>
                  <c:pt idx="10">
                    <c:v>3.9104890572237463E-9</c:v>
                  </c:pt>
                  <c:pt idx="11">
                    <c:v>6.4768691388835563E-8</c:v>
                  </c:pt>
                  <c:pt idx="12">
                    <c:v>1.4395733953101059E-6</c:v>
                  </c:pt>
                  <c:pt idx="13">
                    <c:v>9.7154578627166213E-8</c:v>
                  </c:pt>
                  <c:pt idx="14">
                    <c:v>2.4546961473132811E-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12:$A$26</c:f>
              <c:strCache>
                <c:ptCount val="15"/>
                <c:pt idx="0">
                  <c:v>LMM + 0.5 g/L glucose </c:v>
                </c:pt>
                <c:pt idx="1">
                  <c:v>LMM + 2 g/L glucose</c:v>
                </c:pt>
                <c:pt idx="2">
                  <c:v>LMM + 4 g/L glucose</c:v>
                </c:pt>
                <c:pt idx="3">
                  <c:v>LMM + 6 g/L glucose </c:v>
                </c:pt>
                <c:pt idx="4">
                  <c:v>LMM + 8 g/L glucose </c:v>
                </c:pt>
                <c:pt idx="5">
                  <c:v>LMM + 10 g/L glucose </c:v>
                </c:pt>
                <c:pt idx="6">
                  <c:v>LMM + 15 g/L glucose </c:v>
                </c:pt>
                <c:pt idx="7">
                  <c:v>LMM + 20 g/L glucose </c:v>
                </c:pt>
                <c:pt idx="8">
                  <c:v>LMM + 25 g/L glucose </c:v>
                </c:pt>
                <c:pt idx="9">
                  <c:v>LMM +30 g/L glucose </c:v>
                </c:pt>
                <c:pt idx="10">
                  <c:v>LMM + 35 g/L glucose </c:v>
                </c:pt>
                <c:pt idx="11">
                  <c:v>LMM + 40 g/L glucose </c:v>
                </c:pt>
                <c:pt idx="12">
                  <c:v>LMM + 1% glycerol </c:v>
                </c:pt>
                <c:pt idx="13">
                  <c:v>LMM + 1 mM palmitic acid</c:v>
                </c:pt>
                <c:pt idx="14">
                  <c:v>0.5 x potato dextrose broth</c:v>
                </c:pt>
              </c:strCache>
            </c:strRef>
          </c:cat>
          <c:val>
            <c:numRef>
              <c:f>Sheet1!$B$12:$B$26</c:f>
              <c:numCache>
                <c:formatCode>General</c:formatCode>
                <c:ptCount val="15"/>
                <c:pt idx="0">
                  <c:v>2.5737405882352936E-7</c:v>
                </c:pt>
                <c:pt idx="1">
                  <c:v>-2.7705666666666667E-8</c:v>
                </c:pt>
                <c:pt idx="2">
                  <c:v>1.0555933333333333E-7</c:v>
                </c:pt>
                <c:pt idx="3">
                  <c:v>3.1228729999999997E-5</c:v>
                </c:pt>
                <c:pt idx="4">
                  <c:v>5.8249333333333332E-5</c:v>
                </c:pt>
                <c:pt idx="5">
                  <c:v>2.6507333333333333E-5</c:v>
                </c:pt>
                <c:pt idx="6">
                  <c:v>3.3056666666666666E-6</c:v>
                </c:pt>
                <c:pt idx="7">
                  <c:v>6.6770166666666658E-7</c:v>
                </c:pt>
                <c:pt idx="8">
                  <c:v>-8.2399766666666657E-7</c:v>
                </c:pt>
                <c:pt idx="9">
                  <c:v>1.2067300000000001E-7</c:v>
                </c:pt>
                <c:pt idx="10">
                  <c:v>-2.4321999999999998E-8</c:v>
                </c:pt>
                <c:pt idx="11">
                  <c:v>-7.3181333333333328E-8</c:v>
                </c:pt>
                <c:pt idx="12">
                  <c:v>3.3723633333333336E-7</c:v>
                </c:pt>
                <c:pt idx="13">
                  <c:v>2.573276666666667E-7</c:v>
                </c:pt>
                <c:pt idx="14">
                  <c:v>2.6070219999999995E-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EC8-41C8-A4A3-9E55BECB463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241910096"/>
        <c:axId val="1241911056"/>
      </c:barChart>
      <c:catAx>
        <c:axId val="12419100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41911056"/>
        <c:crosses val="autoZero"/>
        <c:auto val="1"/>
        <c:lblAlgn val="ctr"/>
        <c:lblOffset val="100"/>
        <c:noMultiLvlLbl val="0"/>
      </c:catAx>
      <c:valAx>
        <c:axId val="1241911056"/>
        <c:scaling>
          <c:orientation val="minMax"/>
          <c:min val="-2.0000000000000008E-6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4191009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415ED5-DBD9-4743-9511-B37AED68BA98}" type="datetimeFigureOut">
              <a:rPr lang="en-AU" smtClean="0"/>
              <a:t>23/09/202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2264BF-D238-4EA6-96C0-CF380B460FB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2788509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415ED5-DBD9-4743-9511-B37AED68BA98}" type="datetimeFigureOut">
              <a:rPr lang="en-AU" smtClean="0"/>
              <a:t>23/09/202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2264BF-D238-4EA6-96C0-CF380B460FB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6812032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415ED5-DBD9-4743-9511-B37AED68BA98}" type="datetimeFigureOut">
              <a:rPr lang="en-AU" smtClean="0"/>
              <a:t>23/09/202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2264BF-D238-4EA6-96C0-CF380B460FB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1826513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415ED5-DBD9-4743-9511-B37AED68BA98}" type="datetimeFigureOut">
              <a:rPr lang="en-AU" smtClean="0"/>
              <a:t>23/09/202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2264BF-D238-4EA6-96C0-CF380B460FB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321665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415ED5-DBD9-4743-9511-B37AED68BA98}" type="datetimeFigureOut">
              <a:rPr lang="en-AU" smtClean="0"/>
              <a:t>23/09/202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2264BF-D238-4EA6-96C0-CF380B460FB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768171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415ED5-DBD9-4743-9511-B37AED68BA98}" type="datetimeFigureOut">
              <a:rPr lang="en-AU" smtClean="0"/>
              <a:t>23/09/2024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2264BF-D238-4EA6-96C0-CF380B460FB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895066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415ED5-DBD9-4743-9511-B37AED68BA98}" type="datetimeFigureOut">
              <a:rPr lang="en-AU" smtClean="0"/>
              <a:t>23/09/2024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2264BF-D238-4EA6-96C0-CF380B460FB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281173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415ED5-DBD9-4743-9511-B37AED68BA98}" type="datetimeFigureOut">
              <a:rPr lang="en-AU" smtClean="0"/>
              <a:t>23/09/2024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2264BF-D238-4EA6-96C0-CF380B460FB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623799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415ED5-DBD9-4743-9511-B37AED68BA98}" type="datetimeFigureOut">
              <a:rPr lang="en-AU" smtClean="0"/>
              <a:t>23/09/2024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2264BF-D238-4EA6-96C0-CF380B460FB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7230918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415ED5-DBD9-4743-9511-B37AED68BA98}" type="datetimeFigureOut">
              <a:rPr lang="en-AU" smtClean="0"/>
              <a:t>23/09/2024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2264BF-D238-4EA6-96C0-CF380B460FB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876465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415ED5-DBD9-4743-9511-B37AED68BA98}" type="datetimeFigureOut">
              <a:rPr lang="en-AU" smtClean="0"/>
              <a:t>23/09/2024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2264BF-D238-4EA6-96C0-CF380B460FB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296445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415ED5-DBD9-4743-9511-B37AED68BA98}" type="datetimeFigureOut">
              <a:rPr lang="en-AU" smtClean="0"/>
              <a:t>23/09/202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2264BF-D238-4EA6-96C0-CF380B460FB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7135649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4361670D-6573-491B-B575-E076F96CC7E6}"/>
              </a:ext>
            </a:extLst>
          </p:cNvPr>
          <p:cNvSpPr txBox="1"/>
          <p:nvPr/>
        </p:nvSpPr>
        <p:spPr>
          <a:xfrm>
            <a:off x="478367" y="1065539"/>
            <a:ext cx="6231466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b="1" dirty="0"/>
              <a:t>Fig. S3: </a:t>
            </a:r>
            <a:r>
              <a:rPr lang="en-AU" sz="1400" dirty="0"/>
              <a:t>Optimisation of VHPO expression by media manipulation of 4388 cultures. </a:t>
            </a:r>
          </a:p>
          <a:p>
            <a:r>
              <a:rPr lang="en-AU" sz="1200" dirty="0"/>
              <a:t>Graphs show VHPO enzymatic activity as measured using the phenol red assay with media ingredients labelled on the X-axis. The lower graph is the same dataset as the upper graph except the  LMM+8g/L glucose+0.4 g/L agar value has been removed. </a:t>
            </a:r>
          </a:p>
        </p:txBody>
      </p:sp>
      <p:sp>
        <p:nvSpPr>
          <p:cNvPr id="6" name="Rectangle 6">
            <a:extLst>
              <a:ext uri="{FF2B5EF4-FFF2-40B4-BE49-F238E27FC236}">
                <a16:creationId xmlns:a16="http://schemas.microsoft.com/office/drawing/2014/main" id="{B375C66A-C269-423F-93B9-6B47F274D32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5100" y="728133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AU"/>
          </a:p>
        </p:txBody>
      </p:sp>
      <p:sp>
        <p:nvSpPr>
          <p:cNvPr id="10" name="Rectangle 7">
            <a:extLst>
              <a:ext uri="{FF2B5EF4-FFF2-40B4-BE49-F238E27FC236}">
                <a16:creationId xmlns:a16="http://schemas.microsoft.com/office/drawing/2014/main" id="{69686532-C80E-4341-AC7B-855B233772B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5100" y="1185333"/>
            <a:ext cx="6858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AU"/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DB18F566-5C3B-9FDF-2170-C490319C349A}"/>
              </a:ext>
            </a:extLst>
          </p:cNvPr>
          <p:cNvGrpSpPr/>
          <p:nvPr/>
        </p:nvGrpSpPr>
        <p:grpSpPr>
          <a:xfrm>
            <a:off x="891551" y="2817486"/>
            <a:ext cx="4361766" cy="4103268"/>
            <a:chOff x="891551" y="2817486"/>
            <a:chExt cx="4361766" cy="4103268"/>
          </a:xfrm>
        </p:grpSpPr>
        <p:graphicFrame>
          <p:nvGraphicFramePr>
            <p:cNvPr id="2" name="Chart 1">
              <a:extLst>
                <a:ext uri="{FF2B5EF4-FFF2-40B4-BE49-F238E27FC236}">
                  <a16:creationId xmlns:a16="http://schemas.microsoft.com/office/drawing/2014/main" id="{FCF03FD9-5356-CA53-8D5A-DA47E5CD0CA2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171321767"/>
                </p:ext>
              </p:extLst>
            </p:nvPr>
          </p:nvGraphicFramePr>
          <p:xfrm>
            <a:off x="987050" y="3247791"/>
            <a:ext cx="4266267" cy="367296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745C588E-B1B2-63D5-6105-E80371D3D342}"/>
                </a:ext>
              </a:extLst>
            </p:cNvPr>
            <p:cNvSpPr txBox="1"/>
            <p:nvPr/>
          </p:nvSpPr>
          <p:spPr>
            <a:xfrm rot="16200000">
              <a:off x="-171220" y="3880257"/>
              <a:ext cx="240254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AU" sz="1200" dirty="0"/>
                <a:t>Absorbance OD</a:t>
              </a:r>
              <a:r>
                <a:rPr lang="en-AU" sz="1200" baseline="-25000" dirty="0"/>
                <a:t>590 nm</a:t>
              </a:r>
              <a:r>
                <a:rPr lang="en-AU" sz="1200" dirty="0"/>
                <a:t>/s</a:t>
              </a:r>
            </a:p>
          </p:txBody>
        </p:sp>
      </p:grpSp>
      <p:grpSp>
        <p:nvGrpSpPr>
          <p:cNvPr id="11" name="Group 10">
            <a:extLst>
              <a:ext uri="{FF2B5EF4-FFF2-40B4-BE49-F238E27FC236}">
                <a16:creationId xmlns:a16="http://schemas.microsoft.com/office/drawing/2014/main" id="{8F6CA48E-08D3-F047-B17F-F51F36E91768}"/>
              </a:ext>
            </a:extLst>
          </p:cNvPr>
          <p:cNvGrpSpPr/>
          <p:nvPr/>
        </p:nvGrpSpPr>
        <p:grpSpPr>
          <a:xfrm>
            <a:off x="891550" y="6971974"/>
            <a:ext cx="4142558" cy="4227635"/>
            <a:chOff x="967324" y="6971974"/>
            <a:chExt cx="4142558" cy="4227635"/>
          </a:xfrm>
        </p:grpSpPr>
        <p:graphicFrame>
          <p:nvGraphicFramePr>
            <p:cNvPr id="3" name="Chart 2">
              <a:extLst>
                <a:ext uri="{FF2B5EF4-FFF2-40B4-BE49-F238E27FC236}">
                  <a16:creationId xmlns:a16="http://schemas.microsoft.com/office/drawing/2014/main" id="{C5472D2B-337B-EBE9-0F8F-B7CF3137890D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943601909"/>
                </p:ext>
              </p:extLst>
            </p:nvPr>
          </p:nvGraphicFramePr>
          <p:xfrm>
            <a:off x="1214717" y="7351058"/>
            <a:ext cx="3895165" cy="384855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B9E2EADD-D1B3-FE00-2F9F-14B62968CF3C}"/>
                </a:ext>
              </a:extLst>
            </p:cNvPr>
            <p:cNvSpPr txBox="1"/>
            <p:nvPr/>
          </p:nvSpPr>
          <p:spPr>
            <a:xfrm rot="16200000">
              <a:off x="-95447" y="8034745"/>
              <a:ext cx="240254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AU" sz="1200" dirty="0"/>
                <a:t>Absorbance OD</a:t>
              </a:r>
              <a:r>
                <a:rPr lang="en-AU" sz="1200" baseline="-25000" dirty="0"/>
                <a:t>590 nm</a:t>
              </a:r>
              <a:r>
                <a:rPr lang="en-AU" sz="1200" dirty="0"/>
                <a:t>/s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0642864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4</TotalTime>
  <Words>75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yliffe, Michael (A&amp;F, Black Mountain)</dc:creator>
  <cp:lastModifiedBy>Ayliffe, Michael (A&amp;F, Black Mountain)</cp:lastModifiedBy>
  <cp:revision>31</cp:revision>
  <dcterms:created xsi:type="dcterms:W3CDTF">2022-03-29T03:56:09Z</dcterms:created>
  <dcterms:modified xsi:type="dcterms:W3CDTF">2024-09-23T04:44:37Z</dcterms:modified>
</cp:coreProperties>
</file>